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6" r:id="rId3"/>
    <p:sldId id="25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80" d="100"/>
          <a:sy n="80" d="100"/>
        </p:scale>
        <p:origin x="316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548952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41970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974458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39535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96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44377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57556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458989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1743966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558370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89466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48BFFA-E0E7-4DA6-A251-F1B038C76955}" type="datetimeFigureOut">
              <a:rPr lang="pt-BR" smtClean="0"/>
              <a:t>27/08/2021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77A597-23DB-484C-8D0B-CFC923452F1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518134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juliana.zuliani@fiocruz.br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tângulo 11">
            <a:extLst>
              <a:ext uri="{FF2B5EF4-FFF2-40B4-BE49-F238E27FC236}">
                <a16:creationId xmlns:a16="http://schemas.microsoft.com/office/drawing/2014/main" id="{7D21E336-2D1D-4A22-BCE3-23C0CAF30364}"/>
              </a:ext>
            </a:extLst>
          </p:cNvPr>
          <p:cNvSpPr/>
          <p:nvPr/>
        </p:nvSpPr>
        <p:spPr>
          <a:xfrm>
            <a:off x="196703" y="189269"/>
            <a:ext cx="6464595" cy="46274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tabLst>
                <a:tab pos="4591050" algn="l"/>
                <a:tab pos="4945380" algn="l"/>
                <a:tab pos="5394960" algn="l"/>
                <a:tab pos="5798820" algn="l"/>
              </a:tabLst>
            </a:pPr>
            <a:r>
              <a:rPr lang="en-US" b="1" dirty="0"/>
              <a:t>Inflammasome NLRP3 activation induced by Convulxin, a C-type lectin-like isolated from </a:t>
            </a:r>
            <a:r>
              <a:rPr lang="en-US" i="1" dirty="0"/>
              <a:t>Crotalus </a:t>
            </a:r>
            <a:r>
              <a:rPr lang="en-US" i="1" dirty="0" err="1"/>
              <a:t>durissus</a:t>
            </a:r>
            <a:r>
              <a:rPr lang="en-US" i="1" dirty="0"/>
              <a:t> </a:t>
            </a:r>
            <a:r>
              <a:rPr lang="en-US" i="1" dirty="0" err="1"/>
              <a:t>terrificus</a:t>
            </a:r>
            <a:r>
              <a:rPr lang="en-US" i="1" dirty="0"/>
              <a:t> </a:t>
            </a:r>
            <a:r>
              <a:rPr lang="en-US" b="1" dirty="0"/>
              <a:t>snake venom</a:t>
            </a:r>
            <a:endParaRPr lang="pt-BR" dirty="0"/>
          </a:p>
          <a:p>
            <a:pPr algn="just">
              <a:lnSpc>
                <a:spcPct val="115000"/>
              </a:lnSpc>
              <a:tabLst>
                <a:tab pos="4591050" algn="l"/>
                <a:tab pos="4945380" algn="l"/>
                <a:tab pos="5394960" algn="l"/>
                <a:tab pos="5798820" algn="l"/>
              </a:tabLst>
            </a:pPr>
            <a:endParaRPr lang="nl-NL" sz="1400" b="1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15000"/>
              </a:lnSpc>
              <a:tabLst>
                <a:tab pos="4591050" algn="l"/>
                <a:tab pos="4945380" algn="l"/>
                <a:tab pos="5394960" algn="l"/>
                <a:tab pos="5798820" algn="l"/>
              </a:tabLst>
            </a:pPr>
            <a:r>
              <a:rPr lang="nl-NL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C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ristina M. A. Rego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Aleff F. Francisco</a:t>
            </a:r>
            <a:r>
              <a:rPr lang="nl-NL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nl-NL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C</a:t>
            </a:r>
            <a:r>
              <a:rPr lang="nl-NL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harles N. Boeno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it-I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Mauro V. Paloschi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J</a:t>
            </a:r>
            <a:r>
              <a:rPr lang="fr-FR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é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ssica A. Lope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Milena D. S. Silva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Hallison M. Santana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Suzanne N. Serrath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Jaína E. Rodrigue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Caleb T. L. Lemo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Ricardo S. S. Dutra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</a:t>
            </a:r>
            <a:r>
              <a:rPr lang="nl-NL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Jorddy N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. da Cruz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3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Cleydson Breno R. dos Santo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3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Sulamita da S. Setúbal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Marcos R. M. Fonte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Andreimar M. Soare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4</a:t>
            </a:r>
            <a:r>
              <a:rPr lang="it-I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Weverson L. Pires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pt-P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</a:t>
            </a:r>
            <a:r>
              <a:rPr lang="it-IT" sz="1400" b="1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Juliana P. Zuliani</a:t>
            </a:r>
            <a:r>
              <a:rPr lang="pt-PT" sz="1400" b="1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,4,5 *</a:t>
            </a:r>
            <a:endParaRPr lang="pt-BR" sz="1400" b="1" baseline="3000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15000"/>
              </a:lnSpc>
              <a:tabLst>
                <a:tab pos="4591050" algn="l"/>
                <a:tab pos="4945380" algn="l"/>
                <a:tab pos="5394960" algn="l"/>
                <a:tab pos="5798820" algn="l"/>
              </a:tabLst>
            </a:pP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tabLst>
                <a:tab pos="449580" algn="l"/>
                <a:tab pos="899160" algn="l"/>
                <a:tab pos="1348740" algn="l"/>
                <a:tab pos="1798320" algn="l"/>
                <a:tab pos="2247900" algn="l"/>
                <a:tab pos="2697480" algn="l"/>
                <a:tab pos="3147060" algn="l"/>
                <a:tab pos="3596640" algn="l"/>
                <a:tab pos="4046220" algn="l"/>
                <a:tab pos="4495800" algn="l"/>
                <a:tab pos="4945380" algn="l"/>
                <a:tab pos="5394960" algn="l"/>
                <a:tab pos="5798820" algn="l"/>
              </a:tabLst>
            </a:pPr>
            <a:r>
              <a:rPr lang="en-US" sz="1050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1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Laboratory of Cellular Immunology Applied to Health, Oswaldo Cruz Foundation, FIOCRUZ Rondônia, Porto Velho, RO, Brazil; </a:t>
            </a: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tabLst>
                <a:tab pos="449580" algn="l"/>
                <a:tab pos="899160" algn="l"/>
                <a:tab pos="1348740" algn="l"/>
                <a:tab pos="1798320" algn="l"/>
                <a:tab pos="2247900" algn="l"/>
                <a:tab pos="2697480" algn="l"/>
                <a:tab pos="3147060" algn="l"/>
                <a:tab pos="3596640" algn="l"/>
                <a:tab pos="4046220" algn="l"/>
                <a:tab pos="4495800" algn="l"/>
                <a:tab pos="4945380" algn="l"/>
                <a:tab pos="5394960" algn="l"/>
                <a:tab pos="5798820" algn="l"/>
              </a:tabLst>
            </a:pPr>
            <a:r>
              <a:rPr lang="en-US" sz="1050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2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Department of Physics and Biophysics, Institute of Biosciences, São Paulo State University, UNESP, </a:t>
            </a:r>
            <a:r>
              <a:rPr lang="en-US" sz="105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Botucatu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SP, Brazil; </a:t>
            </a: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tabLst>
                <a:tab pos="449580" algn="l"/>
                <a:tab pos="899160" algn="l"/>
                <a:tab pos="1348740" algn="l"/>
                <a:tab pos="1798320" algn="l"/>
                <a:tab pos="2247900" algn="l"/>
                <a:tab pos="2697480" algn="l"/>
                <a:tab pos="3147060" algn="l"/>
                <a:tab pos="3596640" algn="l"/>
                <a:tab pos="4046220" algn="l"/>
                <a:tab pos="4495800" algn="l"/>
                <a:tab pos="4945380" algn="l"/>
                <a:tab pos="5394960" algn="l"/>
                <a:tab pos="5798820" algn="l"/>
              </a:tabLst>
            </a:pPr>
            <a:r>
              <a:rPr lang="en-US" sz="1050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3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Laboratory of Modeling and Computational Chemistry, Department of Biological and Health Sciences, Federal University of </a:t>
            </a:r>
            <a:r>
              <a:rPr lang="en-US" sz="105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Amapá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</a:t>
            </a:r>
            <a:r>
              <a:rPr lang="en-US" sz="1050" dirty="0" err="1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Macapá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, AP, Brazil;</a:t>
            </a: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tabLst>
                <a:tab pos="449580" algn="l"/>
                <a:tab pos="899160" algn="l"/>
                <a:tab pos="1348740" algn="l"/>
                <a:tab pos="1798320" algn="l"/>
                <a:tab pos="2247900" algn="l"/>
                <a:tab pos="2697480" algn="l"/>
                <a:tab pos="3147060" algn="l"/>
                <a:tab pos="3596640" algn="l"/>
                <a:tab pos="4046220" algn="l"/>
                <a:tab pos="4495800" algn="l"/>
                <a:tab pos="4945380" algn="l"/>
                <a:tab pos="5394960" algn="l"/>
                <a:tab pos="5798820" algn="l"/>
              </a:tabLst>
            </a:pPr>
            <a:r>
              <a:rPr lang="pt-PT" sz="1050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4</a:t>
            </a:r>
            <a:r>
              <a:rPr lang="pt-PT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Center of Biomolecules Applied to Health (CEBio), Fundação Oswaldo Cruz, FIOCRUZ Rondônia, Porto Velho, RO, Brazil;</a:t>
            </a: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tabLst>
                <a:tab pos="449580" algn="l"/>
                <a:tab pos="899160" algn="l"/>
                <a:tab pos="1348740" algn="l"/>
                <a:tab pos="1798320" algn="l"/>
                <a:tab pos="2247900" algn="l"/>
                <a:tab pos="2697480" algn="l"/>
                <a:tab pos="3147060" algn="l"/>
                <a:tab pos="3596640" algn="l"/>
                <a:tab pos="4046220" algn="l"/>
                <a:tab pos="4495800" algn="l"/>
                <a:tab pos="4945380" algn="l"/>
                <a:tab pos="5394960" algn="l"/>
                <a:tab pos="5798820" algn="l"/>
              </a:tabLst>
            </a:pPr>
            <a:r>
              <a:rPr lang="en-US" sz="1050" baseline="3000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5</a:t>
            </a:r>
            <a:r>
              <a:rPr lang="en-US" sz="1050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Department of Medicine, Federal University of Rondônia, UNIR, Porto Velho, RO, Brazil.</a:t>
            </a:r>
            <a:endParaRPr lang="pt-BR" sz="1400" dirty="0">
              <a:ln>
                <a:noFill/>
              </a:ln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>
              <a:lnSpc>
                <a:spcPts val="1205"/>
              </a:lnSpc>
            </a:pPr>
            <a:r>
              <a:rPr lang="en-US" sz="105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*</a:t>
            </a:r>
            <a:r>
              <a:rPr lang="en-US" sz="105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</a:rPr>
              <a:t>Corresponding author </a:t>
            </a:r>
            <a:r>
              <a:rPr lang="en-US" sz="105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 Unicode MS" panose="020B0604020202020204" pitchFamily="34" charset="-128"/>
                <a:hlinkClick r:id="rId2"/>
              </a:rPr>
              <a:t>juliana.zuliani@fiocruz.br</a:t>
            </a:r>
            <a:endParaRPr lang="en-US" sz="105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>
              <a:lnSpc>
                <a:spcPts val="1205"/>
              </a:lnSpc>
            </a:pPr>
            <a:endParaRPr lang="en-US" sz="1050" dirty="0">
              <a:solidFill>
                <a:srgbClr val="000000"/>
              </a:solidFill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>
              <a:lnSpc>
                <a:spcPts val="1205"/>
              </a:lnSpc>
            </a:pPr>
            <a:endParaRPr lang="pt-BR" sz="105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Times New Roman" panose="02020603050405020304" pitchFamily="18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  <p:sp>
        <p:nvSpPr>
          <p:cNvPr id="13" name="Retângulo 12">
            <a:extLst>
              <a:ext uri="{FF2B5EF4-FFF2-40B4-BE49-F238E27FC236}">
                <a16:creationId xmlns:a16="http://schemas.microsoft.com/office/drawing/2014/main" id="{E241CEC5-C65F-4FCB-A1BE-C3DB7C7F43AD}"/>
              </a:ext>
            </a:extLst>
          </p:cNvPr>
          <p:cNvSpPr/>
          <p:nvPr/>
        </p:nvSpPr>
        <p:spPr>
          <a:xfrm>
            <a:off x="2172887" y="6063619"/>
            <a:ext cx="2512226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defTabSz="914400" hangingPunct="0"/>
            <a:r>
              <a:rPr lang="pt-BR" sz="1600" b="1" kern="0" dirty="0" err="1">
                <a:solidFill>
                  <a:srgbClr val="000000"/>
                </a:solidFill>
                <a:latin typeface="Arial"/>
                <a:cs typeface="Arial"/>
                <a:sym typeface="Arial"/>
              </a:rPr>
              <a:t>Supplementary</a:t>
            </a:r>
            <a:r>
              <a:rPr lang="pt-BR" sz="1600" b="1" kern="0" dirty="0">
                <a:solidFill>
                  <a:srgbClr val="000000"/>
                </a:solidFill>
                <a:latin typeface="Arial"/>
                <a:cs typeface="Arial"/>
                <a:sym typeface="Arial"/>
              </a:rPr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4096924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2" name="Imagem 191">
            <a:extLst>
              <a:ext uri="{FF2B5EF4-FFF2-40B4-BE49-F238E27FC236}">
                <a16:creationId xmlns:a16="http://schemas.microsoft.com/office/drawing/2014/main" id="{ED856D02-20B9-4D27-9D9B-252350DEDFC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664"/>
          <a:stretch/>
        </p:blipFill>
        <p:spPr>
          <a:xfrm>
            <a:off x="631032" y="-1"/>
            <a:ext cx="5595936" cy="99060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6621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>
            <a:extLst>
              <a:ext uri="{FF2B5EF4-FFF2-40B4-BE49-F238E27FC236}">
                <a16:creationId xmlns:a16="http://schemas.microsoft.com/office/drawing/2014/main" id="{FFECB6F8-9A18-B047-8B9C-FA4EB3ABD43F}"/>
              </a:ext>
            </a:extLst>
          </p:cNvPr>
          <p:cNvSpPr/>
          <p:nvPr/>
        </p:nvSpPr>
        <p:spPr>
          <a:xfrm>
            <a:off x="308810" y="637454"/>
            <a:ext cx="624037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pt-BR" b="1" dirty="0"/>
              <a:t>Figure S1. </a:t>
            </a:r>
            <a:r>
              <a:rPr lang="pt-BR" b="1" dirty="0" err="1"/>
              <a:t>Protein</a:t>
            </a:r>
            <a:r>
              <a:rPr lang="pt-BR" b="1" dirty="0"/>
              <a:t> </a:t>
            </a:r>
            <a:r>
              <a:rPr lang="pt-BR" b="1" dirty="0" err="1"/>
              <a:t>expression</a:t>
            </a:r>
            <a:r>
              <a:rPr lang="pt-BR" b="1" dirty="0"/>
              <a:t> </a:t>
            </a:r>
            <a:r>
              <a:rPr lang="pt-BR" b="1" dirty="0" err="1"/>
              <a:t>by</a:t>
            </a:r>
            <a:r>
              <a:rPr lang="pt-BR" b="1" dirty="0"/>
              <a:t> Western </a:t>
            </a:r>
            <a:r>
              <a:rPr lang="pt-BR" b="1" dirty="0" err="1"/>
              <a:t>blot</a:t>
            </a:r>
            <a:r>
              <a:rPr lang="pt-BR" b="1" dirty="0"/>
              <a:t>.  </a:t>
            </a:r>
          </a:p>
          <a:p>
            <a:pPr algn="just"/>
            <a:r>
              <a:rPr lang="pt-BR" dirty="0"/>
              <a:t>Western </a:t>
            </a:r>
            <a:r>
              <a:rPr lang="pt-BR" dirty="0" err="1"/>
              <a:t>blot</a:t>
            </a:r>
            <a:r>
              <a:rPr lang="pt-BR" dirty="0"/>
              <a:t> </a:t>
            </a:r>
            <a:r>
              <a:rPr lang="pt-BR" dirty="0" err="1"/>
              <a:t>of</a:t>
            </a:r>
            <a:r>
              <a:rPr lang="pt-BR" dirty="0"/>
              <a:t> NLRP3 (A), CASPASE-1 (</a:t>
            </a:r>
            <a:r>
              <a:rPr lang="pt-BR" dirty="0" err="1"/>
              <a:t>B</a:t>
            </a:r>
            <a:r>
              <a:rPr lang="pt-BR" dirty="0"/>
              <a:t>), IL-1</a:t>
            </a:r>
            <a:r>
              <a:rPr lang="pt-BR" dirty="0">
                <a:latin typeface="Symbol" pitchFamily="2" charset="2"/>
              </a:rPr>
              <a:t>b</a:t>
            </a:r>
            <a:r>
              <a:rPr lang="pt-BR" dirty="0"/>
              <a:t> (C) </a:t>
            </a:r>
            <a:r>
              <a:rPr lang="pt-BR" dirty="0" err="1"/>
              <a:t>and</a:t>
            </a:r>
            <a:r>
              <a:rPr lang="pt-BR" dirty="0"/>
              <a:t> β-</a:t>
            </a:r>
            <a:r>
              <a:rPr lang="pt-BR" dirty="0" err="1"/>
              <a:t>actin</a:t>
            </a:r>
            <a:r>
              <a:rPr lang="pt-BR" dirty="0"/>
              <a:t> (D) </a:t>
            </a:r>
            <a:r>
              <a:rPr lang="pt-BR" dirty="0" err="1"/>
              <a:t>proteins</a:t>
            </a:r>
            <a:r>
              <a:rPr lang="pt-BR" dirty="0"/>
              <a:t> </a:t>
            </a:r>
            <a:r>
              <a:rPr lang="pt-BR" dirty="0" err="1"/>
              <a:t>of</a:t>
            </a:r>
            <a:r>
              <a:rPr lang="pt-BR" dirty="0"/>
              <a:t> </a:t>
            </a:r>
            <a:r>
              <a:rPr lang="pt-BR" dirty="0" err="1"/>
              <a:t>human</a:t>
            </a:r>
            <a:r>
              <a:rPr lang="pt-BR" dirty="0"/>
              <a:t> </a:t>
            </a:r>
            <a:r>
              <a:rPr lang="pt-BR" dirty="0" err="1"/>
              <a:t>PBMCs</a:t>
            </a:r>
            <a:r>
              <a:rPr lang="pt-BR" dirty="0"/>
              <a:t> (1x10</a:t>
            </a:r>
            <a:r>
              <a:rPr lang="pt-BR" baseline="30000" dirty="0"/>
              <a:t>7</a:t>
            </a:r>
            <a:r>
              <a:rPr lang="pt-BR" dirty="0"/>
              <a:t>) </a:t>
            </a:r>
            <a:r>
              <a:rPr lang="pt-BR" dirty="0" err="1"/>
              <a:t>stimulated</a:t>
            </a:r>
            <a:r>
              <a:rPr lang="pt-BR" dirty="0"/>
              <a:t> </a:t>
            </a:r>
            <a:r>
              <a:rPr lang="pt-BR" dirty="0" err="1"/>
              <a:t>with</a:t>
            </a:r>
            <a:r>
              <a:rPr lang="pt-BR" dirty="0"/>
              <a:t> RPMI (negative </a:t>
            </a:r>
            <a:r>
              <a:rPr lang="pt-BR" dirty="0" err="1"/>
              <a:t>control</a:t>
            </a:r>
            <a:r>
              <a:rPr lang="pt-BR" dirty="0"/>
              <a:t>), LPS (1 </a:t>
            </a:r>
            <a:r>
              <a:rPr lang="pt-BR" dirty="0" err="1"/>
              <a:t>μg</a:t>
            </a:r>
            <a:r>
              <a:rPr lang="pt-BR" dirty="0"/>
              <a:t>/</a:t>
            </a:r>
            <a:r>
              <a:rPr lang="pt-BR" dirty="0" err="1"/>
              <a:t>mL</a:t>
            </a:r>
            <a:r>
              <a:rPr lang="pt-BR" dirty="0"/>
              <a:t>; positive </a:t>
            </a:r>
            <a:r>
              <a:rPr lang="pt-BR" dirty="0" err="1"/>
              <a:t>control</a:t>
            </a:r>
            <a:r>
              <a:rPr lang="pt-BR" dirty="0"/>
              <a:t>), </a:t>
            </a:r>
            <a:r>
              <a:rPr lang="pt-BR"/>
              <a:t>and </a:t>
            </a:r>
            <a:r>
              <a:rPr lang="pt-BR" dirty="0"/>
              <a:t>CVX (5 </a:t>
            </a:r>
            <a:r>
              <a:rPr lang="pt-BR" dirty="0" err="1"/>
              <a:t>and</a:t>
            </a:r>
            <a:r>
              <a:rPr lang="pt-BR" dirty="0"/>
              <a:t> 10 </a:t>
            </a:r>
            <a:r>
              <a:rPr lang="pt-BR" dirty="0" err="1"/>
              <a:t>μg</a:t>
            </a:r>
            <a:r>
              <a:rPr lang="pt-BR" dirty="0"/>
              <a:t>/</a:t>
            </a:r>
            <a:r>
              <a:rPr lang="pt-BR" dirty="0" err="1"/>
              <a:t>mL</a:t>
            </a:r>
            <a:r>
              <a:rPr lang="pt-BR" dirty="0"/>
              <a:t>), for 3 hours </a:t>
            </a:r>
            <a:r>
              <a:rPr lang="pt-BR" dirty="0" err="1"/>
              <a:t>at</a:t>
            </a:r>
            <a:r>
              <a:rPr lang="pt-BR" dirty="0"/>
              <a:t> 37°C </a:t>
            </a:r>
            <a:r>
              <a:rPr lang="pt-BR" dirty="0" err="1"/>
              <a:t>and</a:t>
            </a:r>
            <a:r>
              <a:rPr lang="pt-BR" dirty="0"/>
              <a:t> 5% CO</a:t>
            </a:r>
            <a:r>
              <a:rPr lang="pt-BR" baseline="-25000" dirty="0"/>
              <a:t>2 </a:t>
            </a:r>
            <a:r>
              <a:rPr lang="pt-BR" dirty="0" err="1"/>
              <a:t>from</a:t>
            </a:r>
            <a:r>
              <a:rPr lang="pt-BR" dirty="0"/>
              <a:t> </a:t>
            </a:r>
            <a:r>
              <a:rPr lang="pt-BR" dirty="0" err="1"/>
              <a:t>three</a:t>
            </a:r>
            <a:r>
              <a:rPr lang="pt-BR" dirty="0"/>
              <a:t> </a:t>
            </a:r>
            <a:r>
              <a:rPr lang="pt-BR" dirty="0" err="1"/>
              <a:t>different</a:t>
            </a:r>
            <a:r>
              <a:rPr lang="pt-BR" dirty="0"/>
              <a:t> </a:t>
            </a:r>
            <a:r>
              <a:rPr lang="pt-BR" dirty="0" err="1"/>
              <a:t>donors</a:t>
            </a:r>
            <a:r>
              <a:rPr lang="pt-BR" dirty="0"/>
              <a:t> (N).</a:t>
            </a:r>
          </a:p>
        </p:txBody>
      </p:sp>
    </p:spTree>
    <p:extLst>
      <p:ext uri="{BB962C8B-B14F-4D97-AF65-F5344CB8AC3E}">
        <p14:creationId xmlns:p14="http://schemas.microsoft.com/office/powerpoint/2010/main" val="11282370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0</TotalTime>
  <Words>333</Words>
  <Application>Microsoft Macintosh PowerPoint</Application>
  <PresentationFormat>Papel A4 (210 x 297 mm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3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Times New Roman</vt:lpstr>
      <vt:lpstr>Tema do Office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auro Paloschi</dc:creator>
  <cp:lastModifiedBy>Juliana Zuliani</cp:lastModifiedBy>
  <cp:revision>22</cp:revision>
  <dcterms:created xsi:type="dcterms:W3CDTF">2020-02-06T21:49:11Z</dcterms:created>
  <dcterms:modified xsi:type="dcterms:W3CDTF">2021-08-27T17:59:53Z</dcterms:modified>
</cp:coreProperties>
</file>